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318" r:id="rId3"/>
    <p:sldId id="320" r:id="rId4"/>
    <p:sldId id="322" r:id="rId5"/>
    <p:sldId id="324" r:id="rId6"/>
    <p:sldId id="32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7" d="100"/>
          <a:sy n="87" d="100"/>
        </p:scale>
        <p:origin x="212" y="6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C62FE9B-A802-467D-B161-C395FAB44B3C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78FB0EA-4477-4BCB-906C-7AF8169AA6CB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.tiff"/></Relationships>
</file>

<file path=ppt/slides/_rels/slide3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5.tiff"/><Relationship Id="rId2" Type="http://schemas.openxmlformats.org/officeDocument/2006/relationships/image" Target="../media/image4.jpeg"/><Relationship Id="rId1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image" Target="../media/image14.jpeg"/><Relationship Id="rId7" Type="http://schemas.openxmlformats.org/officeDocument/2006/relationships/image" Target="../media/image13.jpeg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761156" y="133176"/>
            <a:ext cx="6506589" cy="356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 Workflow of bioinformatic analysis</a:t>
            </a:r>
            <a:endParaRPr lang="zh-CN" altLang="en-US" sz="171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492885" y="533400"/>
            <a:ext cx="9316720" cy="5861685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761156" y="133176"/>
            <a:ext cx="6506589" cy="6199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2. Differential Expression Analysis of IRDEGs between NF-RV and HF-RV Groups </a:t>
            </a:r>
            <a:endParaRPr lang="zh-CN" altLang="en-US" sz="171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3014107" y="820290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 descr="图表&#10;&#10;描述已自动生成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2872" y="1719378"/>
            <a:ext cx="5546257" cy="3419244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组合 20"/>
          <p:cNvGrpSpPr/>
          <p:nvPr/>
        </p:nvGrpSpPr>
        <p:grpSpPr>
          <a:xfrm>
            <a:off x="1499118" y="1688065"/>
            <a:ext cx="4089695" cy="3344793"/>
            <a:chOff x="13364773" y="16403087"/>
            <a:chExt cx="21948484" cy="16035924"/>
          </a:xfrm>
        </p:grpSpPr>
        <p:grpSp>
          <p:nvGrpSpPr>
            <p:cNvPr id="5" name="组合 4"/>
            <p:cNvGrpSpPr/>
            <p:nvPr/>
          </p:nvGrpSpPr>
          <p:grpSpPr>
            <a:xfrm>
              <a:off x="26648227" y="17333155"/>
              <a:ext cx="8665030" cy="15105856"/>
              <a:chOff x="39972341" y="8406868"/>
              <a:chExt cx="8665030" cy="15105857"/>
            </a:xfrm>
          </p:grpSpPr>
          <p:pic>
            <p:nvPicPr>
              <p:cNvPr id="15" name="图片 3" descr="RS6-5LYC���� CD14 400-1"/>
              <p:cNvPicPr>
                <a:picLocks noChangeArrowheads="1"/>
              </p:cNvPicPr>
              <p:nvPr/>
            </p:nvPicPr>
            <p:blipFill rotWithShape="1">
              <a:blip r:embed="rId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62" t="426" r="274" b="7"/>
              <a:stretch>
                <a:fillRect/>
              </a:stretch>
            </p:blipFill>
            <p:spPr bwMode="auto">
              <a:xfrm>
                <a:off x="39972341" y="8406868"/>
                <a:ext cx="8665030" cy="65035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6" name="图片 9" descr="RS6-5LYC���� CD14 400-1"/>
              <p:cNvPicPr>
                <a:picLocks noChangeArrowheads="1"/>
              </p:cNvPicPr>
              <p:nvPr/>
            </p:nvPicPr>
            <p:blipFill>
              <a:blip r:embed="rId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019" t="50050" r="41833" b="18834"/>
              <a:stretch>
                <a:fillRect/>
              </a:stretch>
            </p:blipFill>
            <p:spPr bwMode="auto">
              <a:xfrm>
                <a:off x="39972341" y="17009178"/>
                <a:ext cx="8665030" cy="65035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7" name="矩形 16"/>
              <p:cNvSpPr/>
              <p:nvPr/>
            </p:nvSpPr>
            <p:spPr>
              <a:xfrm>
                <a:off x="43016235" y="11832347"/>
                <a:ext cx="1643388" cy="1905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zh-CN" altLang="en-US" sz="240" noProof="1">
                  <a:ln w="76200">
                    <a:solidFill>
                      <a:schemeClr val="tx1"/>
                    </a:solidFill>
                  </a:ln>
                  <a:solidFill>
                    <a:schemeClr val="accent4"/>
                  </a:solidFill>
                </a:endParaRPr>
              </a:p>
            </p:txBody>
          </p:sp>
          <p:cxnSp>
            <p:nvCxnSpPr>
              <p:cNvPr id="18" name="直接连接符 17"/>
              <p:cNvCxnSpPr/>
              <p:nvPr/>
            </p:nvCxnSpPr>
            <p:spPr>
              <a:xfrm flipH="1">
                <a:off x="39972341" y="13737347"/>
                <a:ext cx="3043894" cy="327183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  <p:cxnSp>
            <p:nvCxnSpPr>
              <p:cNvPr id="19" name="直接连接符 18"/>
              <p:cNvCxnSpPr/>
              <p:nvPr/>
            </p:nvCxnSpPr>
            <p:spPr>
              <a:xfrm>
                <a:off x="44669413" y="13737347"/>
                <a:ext cx="3967958" cy="327183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</p:grpSp>
        <p:sp>
          <p:nvSpPr>
            <p:cNvPr id="6" name="文本框 5"/>
            <p:cNvSpPr txBox="1"/>
            <p:nvPr/>
          </p:nvSpPr>
          <p:spPr>
            <a:xfrm>
              <a:off x="18772282" y="16403087"/>
              <a:ext cx="3518669" cy="12587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</a:t>
              </a:r>
              <a:endParaRPr lang="zh-CN" altLang="en-US" sz="80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29643929" y="16403087"/>
              <a:ext cx="2631522" cy="12587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VF</a:t>
              </a:r>
              <a:endParaRPr lang="zh-CN" altLang="en-US" sz="80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13364773" y="20250804"/>
              <a:ext cx="2898728" cy="12587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5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14</a:t>
              </a:r>
              <a:endParaRPr lang="zh-CN" altLang="en-US" sz="805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" name="组合 8"/>
            <p:cNvGrpSpPr/>
            <p:nvPr/>
          </p:nvGrpSpPr>
          <p:grpSpPr>
            <a:xfrm>
              <a:off x="15807544" y="17333155"/>
              <a:ext cx="8665030" cy="15105856"/>
              <a:chOff x="29131659" y="8406868"/>
              <a:chExt cx="8665030" cy="15105857"/>
            </a:xfrm>
          </p:grpSpPr>
          <p:pic>
            <p:nvPicPr>
              <p:cNvPr id="10" name="图片 5" descr="RS6-5LYC���� CD14 400-3"/>
              <p:cNvPicPr>
                <a:picLocks noChangeArrowheads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3" t="158" r="-8" b="434"/>
              <a:stretch>
                <a:fillRect/>
              </a:stretch>
            </p:blipFill>
            <p:spPr bwMode="auto">
              <a:xfrm>
                <a:off x="29131659" y="8406868"/>
                <a:ext cx="8665030" cy="65035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1" name="图片 8" descr="RS6-5LYC���� CD14 400-3"/>
              <p:cNvPicPr>
                <a:picLocks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417" t="52715" r="41672" b="16112"/>
              <a:stretch>
                <a:fillRect/>
              </a:stretch>
            </p:blipFill>
            <p:spPr bwMode="auto">
              <a:xfrm>
                <a:off x="29131659" y="17009178"/>
                <a:ext cx="8665030" cy="650354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" name="矩形 11"/>
              <p:cNvSpPr/>
              <p:nvPr/>
            </p:nvSpPr>
            <p:spPr>
              <a:xfrm>
                <a:off x="32532312" y="11938000"/>
                <a:ext cx="1643388" cy="190500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hangingPunct="1">
                  <a:defRPr/>
                </a:pPr>
                <a:endParaRPr lang="zh-CN" altLang="en-US" sz="1600" noProof="1">
                  <a:ln w="76200">
                    <a:solidFill>
                      <a:schemeClr val="tx1"/>
                    </a:solidFill>
                  </a:ln>
                  <a:solidFill>
                    <a:schemeClr val="accent4"/>
                  </a:solidFill>
                </a:endParaRPr>
              </a:p>
            </p:txBody>
          </p:sp>
          <p:cxnSp>
            <p:nvCxnSpPr>
              <p:cNvPr id="13" name="直接连接符 12"/>
              <p:cNvCxnSpPr/>
              <p:nvPr/>
            </p:nvCxnSpPr>
            <p:spPr>
              <a:xfrm flipH="1">
                <a:off x="29131659" y="13843000"/>
                <a:ext cx="3400653" cy="3166178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  <p:cxnSp>
            <p:nvCxnSpPr>
              <p:cNvPr id="14" name="直接连接符 13"/>
              <p:cNvCxnSpPr/>
              <p:nvPr/>
            </p:nvCxnSpPr>
            <p:spPr>
              <a:xfrm>
                <a:off x="34175700" y="13843000"/>
                <a:ext cx="3620989" cy="3166178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</p:cxnSp>
        </p:grpSp>
      </p:grpSp>
      <p:sp>
        <p:nvSpPr>
          <p:cNvPr id="3" name="文本框 2"/>
          <p:cNvSpPr txBox="1"/>
          <p:nvPr/>
        </p:nvSpPr>
        <p:spPr>
          <a:xfrm>
            <a:off x="1622345" y="1178735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761156" y="133176"/>
            <a:ext cx="6506589" cy="6199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3.</a:t>
            </a:r>
            <a:r>
              <a:rPr lang="zh-CN" altLang="en-US" sz="17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7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munohistochemical Staining of CD14 in Control and RVF Cardiac Tissues</a:t>
            </a:r>
            <a:endParaRPr lang="zh-CN" altLang="en-US" sz="171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7082177" y="2563215"/>
            <a:ext cx="2122707" cy="1731570"/>
          </a:xfrm>
          <a:prstGeom prst="rect">
            <a:avLst/>
          </a:prstGeom>
        </p:spPr>
      </p:pic>
      <p:grpSp>
        <p:nvGrpSpPr>
          <p:cNvPr id="25" name="组合 24"/>
          <p:cNvGrpSpPr/>
          <p:nvPr/>
        </p:nvGrpSpPr>
        <p:grpSpPr>
          <a:xfrm>
            <a:off x="1971390" y="3030095"/>
            <a:ext cx="390098" cy="184666"/>
            <a:chOff x="1971390" y="3030095"/>
            <a:chExt cx="390098" cy="184666"/>
          </a:xfrm>
        </p:grpSpPr>
        <p:cxnSp>
          <p:nvCxnSpPr>
            <p:cNvPr id="22" name="直接连接符 21"/>
            <p:cNvCxnSpPr/>
            <p:nvPr/>
          </p:nvCxnSpPr>
          <p:spPr>
            <a:xfrm>
              <a:off x="1993824" y="3175000"/>
              <a:ext cx="30910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1971390" y="3030095"/>
              <a:ext cx="39009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el-GR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组合 25"/>
          <p:cNvGrpSpPr/>
          <p:nvPr/>
        </p:nvGrpSpPr>
        <p:grpSpPr>
          <a:xfrm>
            <a:off x="3978656" y="3027226"/>
            <a:ext cx="390098" cy="184666"/>
            <a:chOff x="1953329" y="3030790"/>
            <a:chExt cx="390098" cy="184666"/>
          </a:xfrm>
        </p:grpSpPr>
        <p:cxnSp>
          <p:nvCxnSpPr>
            <p:cNvPr id="27" name="直接连接符 26"/>
            <p:cNvCxnSpPr/>
            <p:nvPr/>
          </p:nvCxnSpPr>
          <p:spPr>
            <a:xfrm>
              <a:off x="1993824" y="3175000"/>
              <a:ext cx="309109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>
              <a:off x="1953329" y="3030790"/>
              <a:ext cx="39009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 </a:t>
              </a:r>
              <a:r>
                <a:rPr lang="el-GR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μ</a:t>
              </a:r>
              <a:r>
                <a:rPr lang="en-US" altLang="zh-CN" sz="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endParaRPr lang="en-US" altLang="zh-CN" sz="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文本框 28"/>
          <p:cNvSpPr txBox="1"/>
          <p:nvPr/>
        </p:nvSpPr>
        <p:spPr>
          <a:xfrm>
            <a:off x="6788507" y="1178735"/>
            <a:ext cx="285656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18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1"/>
          <a:srcRect t="29826"/>
          <a:stretch>
            <a:fillRect/>
          </a:stretch>
        </p:blipFill>
        <p:spPr bwMode="auto">
          <a:xfrm>
            <a:off x="3690162" y="1500741"/>
            <a:ext cx="4811888" cy="3623216"/>
          </a:xfrm>
          <a:prstGeom prst="rect">
            <a:avLst/>
          </a:prstGeom>
          <a:ln>
            <a:noFill/>
          </a:ln>
        </p:spPr>
      </p:pic>
      <p:sp>
        <p:nvSpPr>
          <p:cNvPr id="3" name="文本框 2"/>
          <p:cNvSpPr txBox="1"/>
          <p:nvPr/>
        </p:nvSpPr>
        <p:spPr>
          <a:xfrm>
            <a:off x="3014107" y="820290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842706" y="133176"/>
            <a:ext cx="6506589" cy="6199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1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4. Construction of protein-protein interaction (PPI) network for SPP1(OPN)</a:t>
            </a:r>
            <a:endParaRPr lang="zh-CN" altLang="en-US" sz="171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2842599" y="43246"/>
            <a:ext cx="6506589" cy="5663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4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5. Establishment and validation of MCT-induced RVF rat model.</a:t>
            </a:r>
            <a:endParaRPr lang="zh-CN" altLang="en-US" sz="154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876739" y="546465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 descr="图示&#10;&#10;描述已自动生成"/>
          <p:cNvPicPr>
            <a:picLocks noChangeAspect="1"/>
          </p:cNvPicPr>
          <p:nvPr/>
        </p:nvPicPr>
        <p:blipFill>
          <a:blip r:embed="rId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56" t="19862" r="14421" b="29153"/>
          <a:stretch>
            <a:fillRect/>
          </a:stretch>
        </p:blipFill>
        <p:spPr>
          <a:xfrm>
            <a:off x="3271399" y="702464"/>
            <a:ext cx="3085310" cy="1435202"/>
          </a:xfrm>
          <a:prstGeom prst="rect">
            <a:avLst/>
          </a:prstGeom>
        </p:spPr>
      </p:pic>
      <p:grpSp>
        <p:nvGrpSpPr>
          <p:cNvPr id="6" name="组合 5"/>
          <p:cNvGrpSpPr/>
          <p:nvPr/>
        </p:nvGrpSpPr>
        <p:grpSpPr>
          <a:xfrm>
            <a:off x="3176473" y="2476128"/>
            <a:ext cx="2860828" cy="1051191"/>
            <a:chOff x="9152602" y="4456158"/>
            <a:chExt cx="24298584" cy="9619607"/>
          </a:xfrm>
        </p:grpSpPr>
        <p:pic>
          <p:nvPicPr>
            <p:cNvPr id="7" name="图片 6" descr="图表, 折线图&#10;&#10;描述已自动生成"/>
            <p:cNvPicPr/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52602" y="5248425"/>
              <a:ext cx="24298584" cy="8827340"/>
            </a:xfrm>
            <a:prstGeom prst="rect">
              <a:avLst/>
            </a:prstGeom>
          </p:spPr>
        </p:pic>
        <p:sp>
          <p:nvSpPr>
            <p:cNvPr id="8" name="文本框 7"/>
            <p:cNvSpPr txBox="1"/>
            <p:nvPr/>
          </p:nvSpPr>
          <p:spPr>
            <a:xfrm>
              <a:off x="10419687" y="4456158"/>
              <a:ext cx="3392901" cy="159953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35" b="1" dirty="0"/>
                <a:t>mmHg</a:t>
              </a:r>
              <a:endParaRPr lang="zh-CN" altLang="en-US" sz="590" b="1" dirty="0"/>
            </a:p>
          </p:txBody>
        </p:sp>
      </p:grpSp>
      <p:sp>
        <p:nvSpPr>
          <p:cNvPr id="9" name="文本框 8"/>
          <p:cNvSpPr txBox="1"/>
          <p:nvPr/>
        </p:nvSpPr>
        <p:spPr>
          <a:xfrm>
            <a:off x="2846679" y="2282363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3176473" y="3613894"/>
            <a:ext cx="2860828" cy="1051191"/>
            <a:chOff x="9152602" y="15293729"/>
            <a:chExt cx="24298584" cy="9750671"/>
          </a:xfrm>
        </p:grpSpPr>
        <p:pic>
          <p:nvPicPr>
            <p:cNvPr id="11" name="图片 10" descr="图形用户界面, 应用程序&#10;&#10;中度可信度描述已自动生成"/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152602" y="16217060"/>
              <a:ext cx="24298584" cy="8827340"/>
            </a:xfrm>
            <a:prstGeom prst="rect">
              <a:avLst/>
            </a:prstGeom>
          </p:spPr>
        </p:pic>
        <p:sp>
          <p:nvSpPr>
            <p:cNvPr id="12" name="文本框 11"/>
            <p:cNvSpPr txBox="1"/>
            <p:nvPr/>
          </p:nvSpPr>
          <p:spPr>
            <a:xfrm>
              <a:off x="10419687" y="15293729"/>
              <a:ext cx="3392901" cy="1621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535" b="1" dirty="0"/>
                <a:t>mmHg</a:t>
              </a:r>
              <a:endParaRPr lang="zh-CN" altLang="en-US" sz="590" b="1" dirty="0"/>
            </a:p>
          </p:txBody>
        </p:sp>
      </p:grpSp>
      <p:sp>
        <p:nvSpPr>
          <p:cNvPr id="13" name="文本框 12"/>
          <p:cNvSpPr txBox="1"/>
          <p:nvPr/>
        </p:nvSpPr>
        <p:spPr>
          <a:xfrm>
            <a:off x="2810047" y="2976987"/>
            <a:ext cx="527709" cy="2158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80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2876739" y="4121236"/>
            <a:ext cx="394660" cy="2158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VF</a:t>
            </a:r>
            <a:endParaRPr lang="zh-CN" altLang="en-US" sz="80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6519043" y="2282363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" name="图片 15" descr="图表&#10;&#10;描述已自动生成"/>
          <p:cNvPicPr/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0759" y="2696446"/>
            <a:ext cx="2098103" cy="1661745"/>
          </a:xfrm>
          <a:prstGeom prst="rect">
            <a:avLst/>
          </a:prstGeom>
        </p:spPr>
      </p:pic>
      <p:pic>
        <p:nvPicPr>
          <p:cNvPr id="17" name="图片 16" descr="图表, 折线图&#10;&#10;描述已自动生成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3138" y="5003547"/>
            <a:ext cx="2647497" cy="1661745"/>
          </a:xfrm>
          <a:prstGeom prst="rect">
            <a:avLst/>
          </a:prstGeom>
        </p:spPr>
      </p:pic>
      <p:sp>
        <p:nvSpPr>
          <p:cNvPr id="18" name="文本框 17"/>
          <p:cNvSpPr txBox="1"/>
          <p:nvPr/>
        </p:nvSpPr>
        <p:spPr>
          <a:xfrm>
            <a:off x="2839031" y="5168603"/>
            <a:ext cx="285656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9" name="图片 18" descr="图表&#10;&#10;描述已自动生成"/>
          <p:cNvPicPr/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810759" y="5006402"/>
            <a:ext cx="2098103" cy="1661745"/>
          </a:xfrm>
          <a:prstGeom prst="rect">
            <a:avLst/>
          </a:prstGeom>
        </p:spPr>
      </p:pic>
      <p:sp>
        <p:nvSpPr>
          <p:cNvPr id="20" name="文本框 19"/>
          <p:cNvSpPr txBox="1"/>
          <p:nvPr/>
        </p:nvSpPr>
        <p:spPr>
          <a:xfrm>
            <a:off x="6519044" y="5168603"/>
            <a:ext cx="27764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图片 21" descr="图片包含 户外, 粉色, 紫色, 服装&#10;&#10;AI 生成的内容可能不正确。"/>
          <p:cNvPicPr/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93943" y="946559"/>
            <a:ext cx="1331734" cy="947011"/>
          </a:xfrm>
          <a:prstGeom prst="rect">
            <a:avLst/>
          </a:prstGeom>
        </p:spPr>
      </p:pic>
      <p:pic>
        <p:nvPicPr>
          <p:cNvPr id="24" name="图片 23" descr="图片包含 珊瑚, 动物, 披萨, 游戏机&#10;&#10;AI 生成的内容可能不正确。"/>
          <p:cNvPicPr/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8862" y="946559"/>
            <a:ext cx="1331734" cy="947011"/>
          </a:xfrm>
          <a:prstGeom prst="rect">
            <a:avLst/>
          </a:prstGeom>
        </p:spPr>
      </p:pic>
      <p:sp>
        <p:nvSpPr>
          <p:cNvPr id="25" name="文本框 24"/>
          <p:cNvSpPr txBox="1"/>
          <p:nvPr/>
        </p:nvSpPr>
        <p:spPr>
          <a:xfrm>
            <a:off x="6628491" y="542996"/>
            <a:ext cx="293670" cy="2736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8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18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7595955" y="750037"/>
            <a:ext cx="527709" cy="2158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lang="zh-CN" altLang="en-US" sz="80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9377399" y="750036"/>
            <a:ext cx="394660" cy="2158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VF</a:t>
            </a:r>
            <a:endParaRPr lang="zh-CN" altLang="en-US" sz="80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6756348" y="1316347"/>
            <a:ext cx="333746" cy="2158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</a:t>
            </a:r>
            <a:endParaRPr lang="zh-CN" altLang="en-US" sz="805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76</Words>
  <Application>WPS 演示</Application>
  <PresentationFormat>宽屏</PresentationFormat>
  <Paragraphs>54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5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等线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旭阳 王</dc:creator>
  <cp:lastModifiedBy>王旭阳</cp:lastModifiedBy>
  <cp:revision>13</cp:revision>
  <dcterms:created xsi:type="dcterms:W3CDTF">2024-12-02T17:41:00Z</dcterms:created>
  <dcterms:modified xsi:type="dcterms:W3CDTF">2025-03-31T12:56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CAD9F361FD5D4F3B8C9DD8F5EF0289F3_12</vt:lpwstr>
  </property>
  <property fmtid="{D5CDD505-2E9C-101B-9397-08002B2CF9AE}" pid="3" name="KSOProductBuildVer">
    <vt:lpwstr>2052-12.1.0.20305</vt:lpwstr>
  </property>
</Properties>
</file>